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9"/>
  </p:notesMasterIdLst>
  <p:sldIdLst>
    <p:sldId id="266" r:id="rId5"/>
    <p:sldId id="263" r:id="rId6"/>
    <p:sldId id="268" r:id="rId7"/>
    <p:sldId id="26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E445D50-51A2-450C-B092-7840C016C1C9}" v="2" dt="2023-02-01T14:30:29.69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87"/>
    <p:restoredTop sz="92722"/>
  </p:normalViewPr>
  <p:slideViewPr>
    <p:cSldViewPr snapToGrid="0" snapToObjects="1">
      <p:cViewPr varScale="1">
        <p:scale>
          <a:sx n="106" d="100"/>
          <a:sy n="106" d="100"/>
        </p:scale>
        <p:origin x="123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N BOON, Saskia" userId="5520dc89-5590-48f0-baf3-792e4aa7abed" providerId="ADAL" clId="{5E445D50-51A2-450C-B092-7840C016C1C9}"/>
    <pc:docChg chg="undo custSel modSld">
      <pc:chgData name="DEN BOON, Saskia" userId="5520dc89-5590-48f0-baf3-792e4aa7abed" providerId="ADAL" clId="{5E445D50-51A2-450C-B092-7840C016C1C9}" dt="2023-02-01T14:52:17.240" v="26" actId="20577"/>
      <pc:docMkLst>
        <pc:docMk/>
      </pc:docMkLst>
      <pc:sldChg chg="modSp mod">
        <pc:chgData name="DEN BOON, Saskia" userId="5520dc89-5590-48f0-baf3-792e4aa7abed" providerId="ADAL" clId="{5E445D50-51A2-450C-B092-7840C016C1C9}" dt="2023-02-01T14:52:17.240" v="26" actId="20577"/>
        <pc:sldMkLst>
          <pc:docMk/>
          <pc:sldMk cId="3791485850" sldId="263"/>
        </pc:sldMkLst>
        <pc:spChg chg="mod">
          <ac:chgData name="DEN BOON, Saskia" userId="5520dc89-5590-48f0-baf3-792e4aa7abed" providerId="ADAL" clId="{5E445D50-51A2-450C-B092-7840C016C1C9}" dt="2023-02-01T14:28:33.974" v="4" actId="207"/>
          <ac:spMkLst>
            <pc:docMk/>
            <pc:sldMk cId="3791485850" sldId="263"/>
            <ac:spMk id="56" creationId="{722CE6D5-2757-4393-98D8-93938E5A728B}"/>
          </ac:spMkLst>
        </pc:spChg>
        <pc:spChg chg="mod">
          <ac:chgData name="DEN BOON, Saskia" userId="5520dc89-5590-48f0-baf3-792e4aa7abed" providerId="ADAL" clId="{5E445D50-51A2-450C-B092-7840C016C1C9}" dt="2023-02-01T14:28:30.458" v="3" actId="207"/>
          <ac:spMkLst>
            <pc:docMk/>
            <pc:sldMk cId="3791485850" sldId="263"/>
            <ac:spMk id="57" creationId="{950E0D96-F3C0-49EB-9F28-B88D5752E31F}"/>
          </ac:spMkLst>
        </pc:spChg>
        <pc:spChg chg="mod">
          <ac:chgData name="DEN BOON, Saskia" userId="5520dc89-5590-48f0-baf3-792e4aa7abed" providerId="ADAL" clId="{5E445D50-51A2-450C-B092-7840C016C1C9}" dt="2023-02-01T14:28:38.132" v="5" actId="13926"/>
          <ac:spMkLst>
            <pc:docMk/>
            <pc:sldMk cId="3791485850" sldId="263"/>
            <ac:spMk id="84" creationId="{FFF6659E-9133-0F4A-A745-644B0DD8608F}"/>
          </ac:spMkLst>
        </pc:spChg>
        <pc:spChg chg="mod">
          <ac:chgData name="DEN BOON, Saskia" userId="5520dc89-5590-48f0-baf3-792e4aa7abed" providerId="ADAL" clId="{5E445D50-51A2-450C-B092-7840C016C1C9}" dt="2023-02-01T14:52:17.240" v="26" actId="20577"/>
          <ac:spMkLst>
            <pc:docMk/>
            <pc:sldMk cId="3791485850" sldId="263"/>
            <ac:spMk id="87" creationId="{953CCEE9-7186-4A37-9C19-39A97CE168F9}"/>
          </ac:spMkLst>
        </pc:spChg>
      </pc:sldChg>
      <pc:sldChg chg="addSp modSp mod">
        <pc:chgData name="DEN BOON, Saskia" userId="5520dc89-5590-48f0-baf3-792e4aa7abed" providerId="ADAL" clId="{5E445D50-51A2-450C-B092-7840C016C1C9}" dt="2023-02-01T14:30:40.455" v="24" actId="14100"/>
        <pc:sldMkLst>
          <pc:docMk/>
          <pc:sldMk cId="1972995285" sldId="268"/>
        </pc:sldMkLst>
        <pc:spChg chg="mod">
          <ac:chgData name="DEN BOON, Saskia" userId="5520dc89-5590-48f0-baf3-792e4aa7abed" providerId="ADAL" clId="{5E445D50-51A2-450C-B092-7840C016C1C9}" dt="2023-02-01T14:29:58.916" v="6" actId="1076"/>
          <ac:spMkLst>
            <pc:docMk/>
            <pc:sldMk cId="1972995285" sldId="268"/>
            <ac:spMk id="5" creationId="{0B329E05-B689-4645-95E2-C668172C4746}"/>
          </ac:spMkLst>
        </pc:spChg>
        <pc:spChg chg="mod">
          <ac:chgData name="DEN BOON, Saskia" userId="5520dc89-5590-48f0-baf3-792e4aa7abed" providerId="ADAL" clId="{5E445D50-51A2-450C-B092-7840C016C1C9}" dt="2023-02-01T14:29:58.916" v="6" actId="1076"/>
          <ac:spMkLst>
            <pc:docMk/>
            <pc:sldMk cId="1972995285" sldId="268"/>
            <ac:spMk id="6" creationId="{E734D89A-9AC1-D54C-958D-8834BF5E700E}"/>
          </ac:spMkLst>
        </pc:spChg>
        <pc:spChg chg="mod">
          <ac:chgData name="DEN BOON, Saskia" userId="5520dc89-5590-48f0-baf3-792e4aa7abed" providerId="ADAL" clId="{5E445D50-51A2-450C-B092-7840C016C1C9}" dt="2023-02-01T14:29:58.916" v="6" actId="1076"/>
          <ac:spMkLst>
            <pc:docMk/>
            <pc:sldMk cId="1972995285" sldId="268"/>
            <ac:spMk id="7" creationId="{6457BA7E-78A6-FB44-AD34-0931ADD6D2F2}"/>
          </ac:spMkLst>
        </pc:spChg>
        <pc:spChg chg="mod">
          <ac:chgData name="DEN BOON, Saskia" userId="5520dc89-5590-48f0-baf3-792e4aa7abed" providerId="ADAL" clId="{5E445D50-51A2-450C-B092-7840C016C1C9}" dt="2023-02-01T14:29:58.916" v="6" actId="1076"/>
          <ac:spMkLst>
            <pc:docMk/>
            <pc:sldMk cId="1972995285" sldId="268"/>
            <ac:spMk id="8" creationId="{01C6B372-A54F-23F0-4D23-58486687288D}"/>
          </ac:spMkLst>
        </pc:spChg>
        <pc:spChg chg="mod">
          <ac:chgData name="DEN BOON, Saskia" userId="5520dc89-5590-48f0-baf3-792e4aa7abed" providerId="ADAL" clId="{5E445D50-51A2-450C-B092-7840C016C1C9}" dt="2023-02-01T14:29:58.916" v="6" actId="1076"/>
          <ac:spMkLst>
            <pc:docMk/>
            <pc:sldMk cId="1972995285" sldId="268"/>
            <ac:spMk id="10" creationId="{127BADF6-C71C-924D-98A3-6572EDBD9E31}"/>
          </ac:spMkLst>
        </pc:spChg>
        <pc:spChg chg="mod">
          <ac:chgData name="DEN BOON, Saskia" userId="5520dc89-5590-48f0-baf3-792e4aa7abed" providerId="ADAL" clId="{5E445D50-51A2-450C-B092-7840C016C1C9}" dt="2023-02-01T14:29:58.916" v="6" actId="1076"/>
          <ac:spMkLst>
            <pc:docMk/>
            <pc:sldMk cId="1972995285" sldId="268"/>
            <ac:spMk id="11" creationId="{18D4B64B-15F8-8C4F-9378-9198A0D60C88}"/>
          </ac:spMkLst>
        </pc:spChg>
        <pc:spChg chg="add mod">
          <ac:chgData name="DEN BOON, Saskia" userId="5520dc89-5590-48f0-baf3-792e4aa7abed" providerId="ADAL" clId="{5E445D50-51A2-450C-B092-7840C016C1C9}" dt="2023-02-01T14:30:25.016" v="21" actId="20577"/>
          <ac:spMkLst>
            <pc:docMk/>
            <pc:sldMk cId="1972995285" sldId="268"/>
            <ac:spMk id="42" creationId="{96D5D154-1E6F-4700-ADD2-0FFF36D24B76}"/>
          </ac:spMkLst>
        </pc:spChg>
        <pc:spChg chg="mod">
          <ac:chgData name="DEN BOON, Saskia" userId="5520dc89-5590-48f0-baf3-792e4aa7abed" providerId="ADAL" clId="{5E445D50-51A2-450C-B092-7840C016C1C9}" dt="2023-02-01T14:30:12.532" v="11"/>
          <ac:spMkLst>
            <pc:docMk/>
            <pc:sldMk cId="1972995285" sldId="268"/>
            <ac:spMk id="48" creationId="{9E6D8CBD-A92B-6548-8C6A-34DAC7D16587}"/>
          </ac:spMkLst>
        </pc:spChg>
        <pc:cxnChg chg="mod">
          <ac:chgData name="DEN BOON, Saskia" userId="5520dc89-5590-48f0-baf3-792e4aa7abed" providerId="ADAL" clId="{5E445D50-51A2-450C-B092-7840C016C1C9}" dt="2023-02-01T14:29:58.916" v="6" actId="1076"/>
          <ac:cxnSpMkLst>
            <pc:docMk/>
            <pc:sldMk cId="1972995285" sldId="268"/>
            <ac:cxnSpMk id="14" creationId="{7A26B8D3-6E33-DC6A-799B-F1FF73579460}"/>
          </ac:cxnSpMkLst>
        </pc:cxnChg>
        <pc:cxnChg chg="mod">
          <ac:chgData name="DEN BOON, Saskia" userId="5520dc89-5590-48f0-baf3-792e4aa7abed" providerId="ADAL" clId="{5E445D50-51A2-450C-B092-7840C016C1C9}" dt="2023-02-01T14:29:58.916" v="6" actId="1076"/>
          <ac:cxnSpMkLst>
            <pc:docMk/>
            <pc:sldMk cId="1972995285" sldId="268"/>
            <ac:cxnSpMk id="25" creationId="{02722083-90CE-7249-9905-F073830DB5CA}"/>
          </ac:cxnSpMkLst>
        </pc:cxnChg>
        <pc:cxnChg chg="mod">
          <ac:chgData name="DEN BOON, Saskia" userId="5520dc89-5590-48f0-baf3-792e4aa7abed" providerId="ADAL" clId="{5E445D50-51A2-450C-B092-7840C016C1C9}" dt="2023-02-01T14:29:58.916" v="6" actId="1076"/>
          <ac:cxnSpMkLst>
            <pc:docMk/>
            <pc:sldMk cId="1972995285" sldId="268"/>
            <ac:cxnSpMk id="27" creationId="{4229C19C-78F8-1647-ACB0-8469C829784E}"/>
          </ac:cxnSpMkLst>
        </pc:cxnChg>
        <pc:cxnChg chg="mod">
          <ac:chgData name="DEN BOON, Saskia" userId="5520dc89-5590-48f0-baf3-792e4aa7abed" providerId="ADAL" clId="{5E445D50-51A2-450C-B092-7840C016C1C9}" dt="2023-02-01T14:30:10.307" v="10" actId="1076"/>
          <ac:cxnSpMkLst>
            <pc:docMk/>
            <pc:sldMk cId="1972995285" sldId="268"/>
            <ac:cxnSpMk id="29" creationId="{8291934F-65E0-2B41-9462-373131EFBA71}"/>
          </ac:cxnSpMkLst>
        </pc:cxnChg>
        <pc:cxnChg chg="mod">
          <ac:chgData name="DEN BOON, Saskia" userId="5520dc89-5590-48f0-baf3-792e4aa7abed" providerId="ADAL" clId="{5E445D50-51A2-450C-B092-7840C016C1C9}" dt="2023-02-01T14:29:58.916" v="6" actId="1076"/>
          <ac:cxnSpMkLst>
            <pc:docMk/>
            <pc:sldMk cId="1972995285" sldId="268"/>
            <ac:cxnSpMk id="39" creationId="{80B1F4D4-30A8-364B-816A-055CE53716EA}"/>
          </ac:cxnSpMkLst>
        </pc:cxnChg>
        <pc:cxnChg chg="mod">
          <ac:chgData name="DEN BOON, Saskia" userId="5520dc89-5590-48f0-baf3-792e4aa7abed" providerId="ADAL" clId="{5E445D50-51A2-450C-B092-7840C016C1C9}" dt="2023-02-01T14:29:58.916" v="6" actId="1076"/>
          <ac:cxnSpMkLst>
            <pc:docMk/>
            <pc:sldMk cId="1972995285" sldId="268"/>
            <ac:cxnSpMk id="41" creationId="{AB0318DB-6E8C-8942-935A-C6E1E3057634}"/>
          </ac:cxnSpMkLst>
        </pc:cxnChg>
        <pc:cxnChg chg="mod">
          <ac:chgData name="DEN BOON, Saskia" userId="5520dc89-5590-48f0-baf3-792e4aa7abed" providerId="ADAL" clId="{5E445D50-51A2-450C-B092-7840C016C1C9}" dt="2023-02-01T14:29:58.916" v="6" actId="1076"/>
          <ac:cxnSpMkLst>
            <pc:docMk/>
            <pc:sldMk cId="1972995285" sldId="268"/>
            <ac:cxnSpMk id="43" creationId="{3FC662C9-0FAA-6C4A-8DB7-DDB2733B0F80}"/>
          </ac:cxnSpMkLst>
        </pc:cxnChg>
        <pc:cxnChg chg="add mod">
          <ac:chgData name="DEN BOON, Saskia" userId="5520dc89-5590-48f0-baf3-792e4aa7abed" providerId="ADAL" clId="{5E445D50-51A2-450C-B092-7840C016C1C9}" dt="2023-02-01T14:30:40.455" v="24" actId="14100"/>
          <ac:cxnSpMkLst>
            <pc:docMk/>
            <pc:sldMk cId="1972995285" sldId="268"/>
            <ac:cxnSpMk id="44" creationId="{C8B9BA15-AF64-4820-BE02-D946934A123C}"/>
          </ac:cxnSpMkLst>
        </pc:cxnChg>
        <pc:cxnChg chg="mod">
          <ac:chgData name="DEN BOON, Saskia" userId="5520dc89-5590-48f0-baf3-792e4aa7abed" providerId="ADAL" clId="{5E445D50-51A2-450C-B092-7840C016C1C9}" dt="2023-02-01T14:30:10.307" v="10" actId="1076"/>
          <ac:cxnSpMkLst>
            <pc:docMk/>
            <pc:sldMk cId="1972995285" sldId="268"/>
            <ac:cxnSpMk id="50" creationId="{AF7E5867-E073-D642-8D0C-E35F66062B81}"/>
          </ac:cxnSpMkLst>
        </pc:cxnChg>
        <pc:cxnChg chg="mod">
          <ac:chgData name="DEN BOON, Saskia" userId="5520dc89-5590-48f0-baf3-792e4aa7abed" providerId="ADAL" clId="{5E445D50-51A2-450C-B092-7840C016C1C9}" dt="2023-02-01T14:30:03.968" v="7" actId="14100"/>
          <ac:cxnSpMkLst>
            <pc:docMk/>
            <pc:sldMk cId="1972995285" sldId="268"/>
            <ac:cxnSpMk id="71" creationId="{BD836749-49AE-7E40-9BF4-7DEA0D5BBD57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D4A799-439A-8D49-85A5-8C35556606C1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EB777A-300C-F34C-B1CA-FE22DA457F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709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312B7C-BDF3-1A4E-87BA-D8DBEF0062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6C4A2B1-4601-A64A-8F4B-FBF5ACA7FA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20E27D-9BC8-EB46-A368-644E91F9D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7D9BB5-B851-F642-A8F7-75119F17E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842D70-7418-424A-955F-0F64DCBB6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751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BE3263-A5F5-304E-8BAF-C71F77A97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1F755B-D06B-0840-85F4-771B2E1996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A2C384-9D27-0249-B1E7-CD0460102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27BD2-2B72-9943-A497-DC7A08440D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D0AC7B-E1A9-1447-90B7-E6F5B199A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2742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F3AE4F-2982-4447-A280-99BDC6A0C4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3FF010-FF22-CF49-9276-2626765BA0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039586-F1B6-8344-B353-3BD9B0CFE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B0FE65-661C-1446-91CF-885A71C5B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E40EB7-A0A6-F34B-BEE6-C16D7613A9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0740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EA7510-E7B7-2C4D-BF3A-EEB65157AF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574A96-9373-C84A-8313-68399EC27F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4F26C9-91D9-4C47-B233-6880AFFEEB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72B0EC-25B0-FF4F-B867-390DCB930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87F8A8-478E-6A45-BC81-06C9CE580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1768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4BA5D6-3D71-9F43-A67E-4C809F58E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5E193F-1BF2-0D40-8662-DA19471174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E709DC-46CE-404E-A2B8-1E8C41BAD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0C3117-012C-CE4E-BB32-AF1B678F1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BBCA50-AD1D-5E4C-949C-E89A5C457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8858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50365E-6BD6-0146-A2E2-1C75D1EB62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8E7521-1220-0445-8487-6667B2669C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CBEBD8-690C-564D-AC38-B07E1CC53B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015F02-79E0-F24A-AB4C-F62B68E56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7F9BE8-C988-EA4B-925F-20832E2E2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1A7132-A9B5-104B-B005-4C190DF7B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9521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57424-F0DF-7648-A255-E734A6C413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9F61F3-8A1D-AC4F-9C17-9915F12D16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E881A9-92D9-AA48-A933-881B7F1453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61AF253-3DF8-474A-A9D9-E8214A5A4F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ABA37F-5983-6F45-AA35-CFB4B3471C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9CCA6E-54E5-914D-BED1-9BF65633BF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D8ED32-DFCD-7C4E-BB8C-CABF3EC17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36EABC-A3D8-5E4B-B5D8-6BED5CD3B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3804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7285AC-B25D-714D-A108-684C859609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BE2437-4320-E34E-B883-6B1C2EB3A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90CEDF-424E-FF40-A52D-99B2F44893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815FC3-E410-2448-97FF-7E8F45C89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0674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2CD3D2-9548-2444-9B58-FBAD172F7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D6B0DC-6B11-AB42-8C61-577904ACE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203D49-9401-BD49-9CE6-E2FD3EEE2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197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CE8B10-3EB4-C544-9767-31A0BA046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49E572-C3A6-B248-A499-83D756DC67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8F343B-0C8A-F740-93C7-0D32D3B88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6A42B5-3E6C-8244-BF32-C8263659E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D8F335-C45F-6044-81D7-C220D8E38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B94A1F-CFCF-BF4B-8387-4A46796D4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6295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D31F82-5B02-C84F-AA64-87F877EA53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97DC31A-7636-3D41-9A08-ABF01FB8FE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729208-5923-FC45-ABB6-15F9A70B6C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427541-306B-4A46-BFB5-3A71E3431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FE5A9E-5897-BC4F-98A3-35F1C1F0A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CBCC29-58C7-5A4A-8F8F-AE3E6597F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1786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460ACFB-EE24-E647-B838-DF7E8410B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F2C64A-BE70-4F40-8178-FEA9D74824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F0E882-590D-B44F-82E4-8F0C4142D4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EA5A7-7E36-D140-8516-68F8398CC435}" type="datetimeFigureOut">
              <a:rPr lang="en-GB" smtClean="0"/>
              <a:t>01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940EE8-DA41-7842-9F62-59397957D3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2E1061-A028-1B46-95F3-1C20077120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A771F1-7DE1-4B4F-8378-36E0202CD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9009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D8526BEA-1D02-AB42-90F3-7FB8F64A8A3E}"/>
              </a:ext>
            </a:extLst>
          </p:cNvPr>
          <p:cNvSpPr/>
          <p:nvPr/>
        </p:nvSpPr>
        <p:spPr>
          <a:xfrm>
            <a:off x="4987636" y="1244105"/>
            <a:ext cx="1690255" cy="38301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Symptom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B329E05-B689-4645-95E2-C668172C4746}"/>
              </a:ext>
            </a:extLst>
          </p:cNvPr>
          <p:cNvSpPr/>
          <p:nvPr/>
        </p:nvSpPr>
        <p:spPr>
          <a:xfrm>
            <a:off x="4504916" y="2042543"/>
            <a:ext cx="2633472" cy="38301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>
                <a:solidFill>
                  <a:schemeClr val="tx1"/>
                </a:solidFill>
              </a:rPr>
              <a:t>mWRDs</a:t>
            </a:r>
            <a:r>
              <a:rPr lang="en-GB" sz="1600" dirty="0">
                <a:solidFill>
                  <a:schemeClr val="tx1"/>
                </a:solidFill>
              </a:rPr>
              <a:t> (</a:t>
            </a:r>
            <a:r>
              <a:rPr lang="en-GB" sz="1600" dirty="0" err="1">
                <a:solidFill>
                  <a:schemeClr val="tx1"/>
                </a:solidFill>
              </a:rPr>
              <a:t>Xpert</a:t>
            </a:r>
            <a:r>
              <a:rPr lang="en-GB" sz="1600" dirty="0">
                <a:solidFill>
                  <a:schemeClr val="tx1"/>
                </a:solidFill>
              </a:rPr>
              <a:t> MTB/Rif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734D89A-9AC1-D54C-958D-8834BF5E700E}"/>
              </a:ext>
            </a:extLst>
          </p:cNvPr>
          <p:cNvSpPr/>
          <p:nvPr/>
        </p:nvSpPr>
        <p:spPr>
          <a:xfrm>
            <a:off x="3048001" y="3152960"/>
            <a:ext cx="1463040" cy="38301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>
                <a:solidFill>
                  <a:schemeClr val="tx1"/>
                </a:solidFill>
              </a:rPr>
              <a:t>M.tb</a:t>
            </a:r>
            <a:r>
              <a:rPr lang="en-GB" sz="1600" dirty="0">
                <a:solidFill>
                  <a:schemeClr val="tx1"/>
                </a:solidFill>
              </a:rPr>
              <a:t>-Positive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457BA7E-78A6-FB44-AD34-0931ADD6D2F2}"/>
              </a:ext>
            </a:extLst>
          </p:cNvPr>
          <p:cNvSpPr/>
          <p:nvPr/>
        </p:nvSpPr>
        <p:spPr>
          <a:xfrm>
            <a:off x="6480049" y="3166105"/>
            <a:ext cx="1463040" cy="38301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>
                <a:solidFill>
                  <a:schemeClr val="tx1"/>
                </a:solidFill>
              </a:rPr>
              <a:t>M.tb</a:t>
            </a:r>
            <a:r>
              <a:rPr lang="en-GB" sz="1600" dirty="0">
                <a:solidFill>
                  <a:schemeClr val="tx1"/>
                </a:solidFill>
              </a:rPr>
              <a:t> Negative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9E40E8E-DAB6-8F4D-ADB9-725148BBB943}"/>
              </a:ext>
            </a:extLst>
          </p:cNvPr>
          <p:cNvSpPr/>
          <p:nvPr/>
        </p:nvSpPr>
        <p:spPr>
          <a:xfrm>
            <a:off x="2196936" y="3681313"/>
            <a:ext cx="3120994" cy="96946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Bacteriologically confirmed TB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27BADF6-C71C-924D-98A3-6572EDBD9E31}"/>
              </a:ext>
            </a:extLst>
          </p:cNvPr>
          <p:cNvSpPr/>
          <p:nvPr/>
        </p:nvSpPr>
        <p:spPr>
          <a:xfrm>
            <a:off x="6205729" y="3833600"/>
            <a:ext cx="2036064" cy="96946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Clinical evaluation + Chest X-Ray (if not already done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8D4B64B-15F8-8C4F-9378-9198A0D60C88}"/>
              </a:ext>
            </a:extLst>
          </p:cNvPr>
          <p:cNvSpPr/>
          <p:nvPr/>
        </p:nvSpPr>
        <p:spPr>
          <a:xfrm>
            <a:off x="6217304" y="5031176"/>
            <a:ext cx="2036064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TB</a:t>
            </a:r>
            <a:endParaRPr lang="en-GB" sz="1600" dirty="0">
              <a:solidFill>
                <a:schemeClr val="tx1"/>
              </a:solidFill>
              <a:highlight>
                <a:srgbClr val="FFFF00"/>
              </a:highlight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985A960-0FB2-9545-AF9C-8A4C73A6C7BE}"/>
              </a:ext>
            </a:extLst>
          </p:cNvPr>
          <p:cNvSpPr/>
          <p:nvPr/>
        </p:nvSpPr>
        <p:spPr>
          <a:xfrm>
            <a:off x="8412481" y="4134361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No TB</a:t>
            </a:r>
          </a:p>
        </p:txBody>
      </p:sp>
      <p:cxnSp>
        <p:nvCxnSpPr>
          <p:cNvPr id="25" name="Elbow Connector 24">
            <a:extLst>
              <a:ext uri="{FF2B5EF4-FFF2-40B4-BE49-F238E27FC236}">
                <a16:creationId xmlns:a16="http://schemas.microsoft.com/office/drawing/2014/main" id="{02722083-90CE-7249-9905-F073830DB5CA}"/>
              </a:ext>
            </a:extLst>
          </p:cNvPr>
          <p:cNvCxnSpPr>
            <a:stCxn id="5" idx="2"/>
            <a:endCxn id="6" idx="0"/>
          </p:cNvCxnSpPr>
          <p:nvPr/>
        </p:nvCxnSpPr>
        <p:spPr>
          <a:xfrm rot="5400000">
            <a:off x="4436888" y="1768196"/>
            <a:ext cx="727398" cy="2042131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Elbow Connector 26">
            <a:extLst>
              <a:ext uri="{FF2B5EF4-FFF2-40B4-BE49-F238E27FC236}">
                <a16:creationId xmlns:a16="http://schemas.microsoft.com/office/drawing/2014/main" id="{4229C19C-78F8-1647-ACB0-8469C829784E}"/>
              </a:ext>
            </a:extLst>
          </p:cNvPr>
          <p:cNvCxnSpPr>
            <a:stCxn id="5" idx="2"/>
            <a:endCxn id="7" idx="0"/>
          </p:cNvCxnSpPr>
          <p:nvPr/>
        </p:nvCxnSpPr>
        <p:spPr>
          <a:xfrm rot="16200000" flipH="1">
            <a:off x="6146339" y="2100874"/>
            <a:ext cx="740543" cy="1389917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80B1F4D4-30A8-364B-816A-055CE53716EA}"/>
              </a:ext>
            </a:extLst>
          </p:cNvPr>
          <p:cNvCxnSpPr>
            <a:cxnSpLocks/>
            <a:stCxn id="10" idx="3"/>
            <a:endCxn id="13" idx="1"/>
          </p:cNvCxnSpPr>
          <p:nvPr/>
        </p:nvCxnSpPr>
        <p:spPr>
          <a:xfrm>
            <a:off x="8241793" y="4318333"/>
            <a:ext cx="170688" cy="75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AB0318DB-6E8C-8942-935A-C6E1E3057634}"/>
              </a:ext>
            </a:extLst>
          </p:cNvPr>
          <p:cNvCxnSpPr>
            <a:cxnSpLocks/>
            <a:stCxn id="7" idx="2"/>
            <a:endCxn id="10" idx="0"/>
          </p:cNvCxnSpPr>
          <p:nvPr/>
        </p:nvCxnSpPr>
        <p:spPr>
          <a:xfrm>
            <a:off x="7211569" y="3549124"/>
            <a:ext cx="12192" cy="2844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3FC662C9-0FAA-6C4A-8DB7-DDB2733B0F80}"/>
              </a:ext>
            </a:extLst>
          </p:cNvPr>
          <p:cNvCxnSpPr>
            <a:cxnSpLocks/>
            <a:stCxn id="10" idx="2"/>
            <a:endCxn id="11" idx="0"/>
          </p:cNvCxnSpPr>
          <p:nvPr/>
        </p:nvCxnSpPr>
        <p:spPr>
          <a:xfrm>
            <a:off x="7223761" y="4803065"/>
            <a:ext cx="11575" cy="2281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937DB757-AED9-784D-AE70-FD145ADCAFE5}"/>
              </a:ext>
            </a:extLst>
          </p:cNvPr>
          <p:cNvCxnSpPr>
            <a:cxnSpLocks/>
            <a:stCxn id="6" idx="2"/>
            <a:endCxn id="9" idx="0"/>
          </p:cNvCxnSpPr>
          <p:nvPr/>
        </p:nvCxnSpPr>
        <p:spPr>
          <a:xfrm flipH="1">
            <a:off x="3757433" y="3535979"/>
            <a:ext cx="22088" cy="1453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BD836749-49AE-7E40-9BF4-7DEA0D5BBD57}"/>
              </a:ext>
            </a:extLst>
          </p:cNvPr>
          <p:cNvCxnSpPr>
            <a:cxnSpLocks/>
            <a:stCxn id="3" idx="2"/>
            <a:endCxn id="5" idx="0"/>
          </p:cNvCxnSpPr>
          <p:nvPr/>
        </p:nvCxnSpPr>
        <p:spPr>
          <a:xfrm flipH="1">
            <a:off x="5821652" y="1627124"/>
            <a:ext cx="11112" cy="4154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74">
            <a:extLst>
              <a:ext uri="{FF2B5EF4-FFF2-40B4-BE49-F238E27FC236}">
                <a16:creationId xmlns:a16="http://schemas.microsoft.com/office/drawing/2014/main" id="{3BC86454-6AC1-324B-BF3D-F9584761EAA5}"/>
              </a:ext>
            </a:extLst>
          </p:cNvPr>
          <p:cNvSpPr/>
          <p:nvPr/>
        </p:nvSpPr>
        <p:spPr>
          <a:xfrm>
            <a:off x="324196" y="1244105"/>
            <a:ext cx="2211725" cy="156447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FF0000"/>
                </a:solidFill>
              </a:rPr>
              <a:t>Algorithm for TB</a:t>
            </a:r>
          </a:p>
          <a:p>
            <a:pPr algn="ctr"/>
            <a:r>
              <a:rPr lang="en-GB" sz="1600" b="1" dirty="0">
                <a:solidFill>
                  <a:srgbClr val="FF0000"/>
                </a:solidFill>
              </a:rPr>
              <a:t>passive case finding</a:t>
            </a:r>
          </a:p>
        </p:txBody>
      </p:sp>
    </p:spTree>
    <p:extLst>
      <p:ext uri="{BB962C8B-B14F-4D97-AF65-F5344CB8AC3E}">
        <p14:creationId xmlns:p14="http://schemas.microsoft.com/office/powerpoint/2010/main" val="15657434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690F115-29FD-7E42-AB6B-42056F818965}"/>
              </a:ext>
            </a:extLst>
          </p:cNvPr>
          <p:cNvGrpSpPr/>
          <p:nvPr/>
        </p:nvGrpSpPr>
        <p:grpSpPr>
          <a:xfrm>
            <a:off x="1619248" y="184416"/>
            <a:ext cx="7303759" cy="5783657"/>
            <a:chOff x="1619248" y="184416"/>
            <a:chExt cx="7303759" cy="5783657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AC55C4C-C49C-0941-A7D1-2B855ABEDD6D}"/>
                </a:ext>
              </a:extLst>
            </p:cNvPr>
            <p:cNvSpPr txBox="1"/>
            <p:nvPr/>
          </p:nvSpPr>
          <p:spPr>
            <a:xfrm>
              <a:off x="4728476" y="184416"/>
              <a:ext cx="561160" cy="26161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>
                  <a:solidFill>
                    <a:srgbClr val="FF0000"/>
                  </a:solidFill>
                </a:rPr>
                <a:t>PLHIV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FA9453EF-AA62-8744-AEFB-53C6782586A5}"/>
                </a:ext>
              </a:extLst>
            </p:cNvPr>
            <p:cNvSpPr txBox="1"/>
            <p:nvPr/>
          </p:nvSpPr>
          <p:spPr>
            <a:xfrm>
              <a:off x="3929335" y="716905"/>
              <a:ext cx="2184364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Information, education about TB</a:t>
              </a:r>
              <a:endParaRPr lang="en-GB" sz="1100" strike="sngStrike" dirty="0"/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88C59817-761F-C649-9849-B8F0F4B5F1CD}"/>
                </a:ext>
              </a:extLst>
            </p:cNvPr>
            <p:cNvSpPr txBox="1"/>
            <p:nvPr/>
          </p:nvSpPr>
          <p:spPr>
            <a:xfrm>
              <a:off x="5993328" y="3341345"/>
              <a:ext cx="2175310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Assess eligibility for TPT 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AF2105F4-F078-EE42-8BF6-6071C5C09C5B}"/>
                </a:ext>
              </a:extLst>
            </p:cNvPr>
            <p:cNvSpPr txBox="1"/>
            <p:nvPr/>
          </p:nvSpPr>
          <p:spPr>
            <a:xfrm>
              <a:off x="1969395" y="2769955"/>
              <a:ext cx="1856193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 Suggestive of TB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32991AD3-9402-4F42-A091-1F9570112BD1}"/>
                </a:ext>
              </a:extLst>
            </p:cNvPr>
            <p:cNvSpPr txBox="1"/>
            <p:nvPr/>
          </p:nvSpPr>
          <p:spPr>
            <a:xfrm>
              <a:off x="3583428" y="4158747"/>
              <a:ext cx="1014785" cy="26161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Negative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D4C46A5B-DE3B-CD43-92D8-94170CD3D48A}"/>
                </a:ext>
              </a:extLst>
            </p:cNvPr>
            <p:cNvSpPr txBox="1"/>
            <p:nvPr/>
          </p:nvSpPr>
          <p:spPr>
            <a:xfrm>
              <a:off x="1946817" y="4997282"/>
              <a:ext cx="1014785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Positive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404CCEE9-CBEB-CF4A-B0A9-8CFBC2EE2B9E}"/>
                </a:ext>
              </a:extLst>
            </p:cNvPr>
            <p:cNvSpPr txBox="1"/>
            <p:nvPr/>
          </p:nvSpPr>
          <p:spPr>
            <a:xfrm>
              <a:off x="6351401" y="2785856"/>
              <a:ext cx="1479840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 Not Suggestive of TB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FFF6659E-9133-0F4A-A745-644B0DD8608F}"/>
                </a:ext>
              </a:extLst>
            </p:cNvPr>
            <p:cNvSpPr txBox="1"/>
            <p:nvPr/>
          </p:nvSpPr>
          <p:spPr>
            <a:xfrm>
              <a:off x="1619248" y="5706463"/>
              <a:ext cx="1669924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TB</a:t>
              </a:r>
            </a:p>
          </p:txBody>
        </p:sp>
        <p:cxnSp>
          <p:nvCxnSpPr>
            <p:cNvPr id="94" name="Straight Arrow Connector 93">
              <a:extLst>
                <a:ext uri="{FF2B5EF4-FFF2-40B4-BE49-F238E27FC236}">
                  <a16:creationId xmlns:a16="http://schemas.microsoft.com/office/drawing/2014/main" id="{745F8D95-3849-474D-9F03-2026471E93D5}"/>
                </a:ext>
              </a:extLst>
            </p:cNvPr>
            <p:cNvCxnSpPr>
              <a:cxnSpLocks/>
              <a:stCxn id="79" idx="2"/>
              <a:endCxn id="87" idx="0"/>
            </p:cNvCxnSpPr>
            <p:nvPr/>
          </p:nvCxnSpPr>
          <p:spPr>
            <a:xfrm flipH="1">
              <a:off x="2895786" y="3031565"/>
              <a:ext cx="1706" cy="176214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Elbow Connector 95">
              <a:extLst>
                <a:ext uri="{FF2B5EF4-FFF2-40B4-BE49-F238E27FC236}">
                  <a16:creationId xmlns:a16="http://schemas.microsoft.com/office/drawing/2014/main" id="{14B8FFEB-DA02-F64B-B615-08009218E8C4}"/>
                </a:ext>
              </a:extLst>
            </p:cNvPr>
            <p:cNvCxnSpPr>
              <a:cxnSpLocks/>
              <a:stCxn id="87" idx="2"/>
              <a:endCxn id="82" idx="0"/>
            </p:cNvCxnSpPr>
            <p:nvPr/>
          </p:nvCxnSpPr>
          <p:spPr>
            <a:xfrm rot="5400000">
              <a:off x="1911052" y="4012547"/>
              <a:ext cx="1527893" cy="441576"/>
            </a:xfrm>
            <a:prstGeom prst="bentConnector3">
              <a:avLst>
                <a:gd name="adj1" fmla="val 22439"/>
              </a:avLst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Elbow Connector 97">
              <a:extLst>
                <a:ext uri="{FF2B5EF4-FFF2-40B4-BE49-F238E27FC236}">
                  <a16:creationId xmlns:a16="http://schemas.microsoft.com/office/drawing/2014/main" id="{497A13CA-8534-2B4B-8B14-94C30146A8D7}"/>
                </a:ext>
              </a:extLst>
            </p:cNvPr>
            <p:cNvCxnSpPr>
              <a:cxnSpLocks/>
              <a:stCxn id="87" idx="2"/>
              <a:endCxn id="80" idx="0"/>
            </p:cNvCxnSpPr>
            <p:nvPr/>
          </p:nvCxnSpPr>
          <p:spPr>
            <a:xfrm rot="16200000" flipH="1">
              <a:off x="3148624" y="3216550"/>
              <a:ext cx="689358" cy="1195035"/>
            </a:xfrm>
            <a:prstGeom prst="bentConnector3">
              <a:avLst>
                <a:gd name="adj1" fmla="val 50000"/>
              </a:avLst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4FFAD783-5E35-6B40-92B2-CBA32AF6DF5C}"/>
                </a:ext>
              </a:extLst>
            </p:cNvPr>
            <p:cNvSpPr txBox="1"/>
            <p:nvPr/>
          </p:nvSpPr>
          <p:spPr>
            <a:xfrm>
              <a:off x="4645952" y="3262321"/>
              <a:ext cx="964359" cy="430887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No TB, Enrol on ART 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8275961A-B51A-104D-A509-21A9790CC2E5}"/>
                </a:ext>
              </a:extLst>
            </p:cNvPr>
            <p:cNvSpPr txBox="1"/>
            <p:nvPr/>
          </p:nvSpPr>
          <p:spPr>
            <a:xfrm>
              <a:off x="6717668" y="3805283"/>
              <a:ext cx="724727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Yes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5CAE24FD-B056-3849-8DAC-581F950B5965}"/>
                </a:ext>
              </a:extLst>
            </p:cNvPr>
            <p:cNvSpPr txBox="1"/>
            <p:nvPr/>
          </p:nvSpPr>
          <p:spPr>
            <a:xfrm>
              <a:off x="6411625" y="4248071"/>
              <a:ext cx="1336812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TPT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5AF89F7-C6C6-EA41-845D-44686FBA2D02}"/>
                </a:ext>
              </a:extLst>
            </p:cNvPr>
            <p:cNvSpPr txBox="1"/>
            <p:nvPr/>
          </p:nvSpPr>
          <p:spPr>
            <a:xfrm>
              <a:off x="3278923" y="4985945"/>
              <a:ext cx="1657939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Clinical evaluation for TB</a:t>
              </a:r>
              <a:endParaRPr lang="en-GB" sz="1100" dirty="0">
                <a:highlight>
                  <a:srgbClr val="FFFF00"/>
                </a:highlight>
              </a:endParaRP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DD3CD401-EE27-C247-B71B-F515417378A2}"/>
                </a:ext>
              </a:extLst>
            </p:cNvPr>
            <p:cNvCxnSpPr>
              <a:stCxn id="82" idx="2"/>
              <a:endCxn id="84" idx="0"/>
            </p:cNvCxnSpPr>
            <p:nvPr/>
          </p:nvCxnSpPr>
          <p:spPr>
            <a:xfrm>
              <a:off x="2454210" y="5258892"/>
              <a:ext cx="0" cy="447571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A600025D-6308-F84F-8DBD-012751B28F88}"/>
                </a:ext>
              </a:extLst>
            </p:cNvPr>
            <p:cNvCxnSpPr>
              <a:cxnSpLocks/>
              <a:stCxn id="83" idx="2"/>
              <a:endCxn id="77" idx="0"/>
            </p:cNvCxnSpPr>
            <p:nvPr/>
          </p:nvCxnSpPr>
          <p:spPr>
            <a:xfrm flipH="1">
              <a:off x="7080983" y="3047466"/>
              <a:ext cx="10338" cy="29387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Arrow Connector 66">
              <a:extLst>
                <a:ext uri="{FF2B5EF4-FFF2-40B4-BE49-F238E27FC236}">
                  <a16:creationId xmlns:a16="http://schemas.microsoft.com/office/drawing/2014/main" id="{C25542D0-E83E-4B4B-BF7E-AF2144DA6E16}"/>
                </a:ext>
              </a:extLst>
            </p:cNvPr>
            <p:cNvCxnSpPr>
              <a:cxnSpLocks/>
              <a:stCxn id="80" idx="2"/>
              <a:endCxn id="38" idx="0"/>
            </p:cNvCxnSpPr>
            <p:nvPr/>
          </p:nvCxnSpPr>
          <p:spPr>
            <a:xfrm>
              <a:off x="4090821" y="4420357"/>
              <a:ext cx="17072" cy="5655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Arrow Connector 137">
              <a:extLst>
                <a:ext uri="{FF2B5EF4-FFF2-40B4-BE49-F238E27FC236}">
                  <a16:creationId xmlns:a16="http://schemas.microsoft.com/office/drawing/2014/main" id="{1E76AF04-B83E-7442-AF61-653370EEB330}"/>
                </a:ext>
              </a:extLst>
            </p:cNvPr>
            <p:cNvCxnSpPr>
              <a:cxnSpLocks/>
              <a:stCxn id="56" idx="2"/>
              <a:endCxn id="83" idx="0"/>
            </p:cNvCxnSpPr>
            <p:nvPr/>
          </p:nvCxnSpPr>
          <p:spPr>
            <a:xfrm>
              <a:off x="2906762" y="2218253"/>
              <a:ext cx="4184559" cy="567603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Arrow Connector 148">
              <a:extLst>
                <a:ext uri="{FF2B5EF4-FFF2-40B4-BE49-F238E27FC236}">
                  <a16:creationId xmlns:a16="http://schemas.microsoft.com/office/drawing/2014/main" id="{9FFE94CE-0172-FC45-9CE7-F5B174A92C4A}"/>
                </a:ext>
              </a:extLst>
            </p:cNvPr>
            <p:cNvCxnSpPr>
              <a:cxnSpLocks/>
              <a:stCxn id="107" idx="2"/>
              <a:endCxn id="117" idx="0"/>
            </p:cNvCxnSpPr>
            <p:nvPr/>
          </p:nvCxnSpPr>
          <p:spPr>
            <a:xfrm flipH="1">
              <a:off x="7080031" y="4066893"/>
              <a:ext cx="1" cy="18117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D11310E6-35C2-F242-A0BF-F39555564399}"/>
                </a:ext>
              </a:extLst>
            </p:cNvPr>
            <p:cNvSpPr txBox="1"/>
            <p:nvPr/>
          </p:nvSpPr>
          <p:spPr>
            <a:xfrm>
              <a:off x="8512184" y="3337573"/>
              <a:ext cx="410823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No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22CE6D5-2757-4393-98D8-93938E5A728B}"/>
                </a:ext>
              </a:extLst>
            </p:cNvPr>
            <p:cNvSpPr txBox="1"/>
            <p:nvPr/>
          </p:nvSpPr>
          <p:spPr>
            <a:xfrm>
              <a:off x="1619248" y="1448812"/>
              <a:ext cx="2575028" cy="769441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/>
                <a:t>PLHIV not enrolled on ART: </a:t>
              </a:r>
              <a:r>
                <a:rPr lang="en-GB" sz="1100" dirty="0"/>
                <a:t>Screen for TB symptoms (W4SS) and then CRP</a:t>
              </a:r>
              <a:r>
                <a:rPr lang="en-GB" sz="1100" dirty="0">
                  <a:solidFill>
                    <a:srgbClr val="FF0000"/>
                  </a:solidFill>
                </a:rPr>
                <a:t> </a:t>
              </a:r>
            </a:p>
            <a:p>
              <a:pPr algn="ctr"/>
              <a:r>
                <a:rPr lang="en-GB" sz="1100" dirty="0"/>
                <a:t>(positive or abnormal result on both is considered suggestive of TB)</a:t>
              </a:r>
              <a:endParaRPr lang="en-GB" sz="1100" strike="sngStrike" dirty="0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50E0D96-F3C0-49EB-9F28-B88D5752E31F}"/>
                </a:ext>
              </a:extLst>
            </p:cNvPr>
            <p:cNvSpPr txBox="1"/>
            <p:nvPr/>
          </p:nvSpPr>
          <p:spPr>
            <a:xfrm>
              <a:off x="5709365" y="1454059"/>
              <a:ext cx="2773296" cy="938719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/>
                <a:t>PLHIV enrolled on ART: </a:t>
              </a:r>
              <a:r>
                <a:rPr lang="en-GB" sz="1100" dirty="0"/>
                <a:t>Screen for TB symptoms (W4SS) and CXR with CAD</a:t>
              </a:r>
            </a:p>
            <a:p>
              <a:pPr algn="ctr"/>
              <a:r>
                <a:rPr lang="en-GB" sz="1100" dirty="0"/>
                <a:t>(positive or abnormal result on either is considered suggestive of TB)</a:t>
              </a:r>
              <a:endParaRPr lang="en-GB" sz="1100" strike="sngStrike" dirty="0"/>
            </a:p>
            <a:p>
              <a:pPr algn="ctr"/>
              <a:endParaRPr lang="en-GB" sz="1100" strike="sngStrike" dirty="0"/>
            </a:p>
          </p:txBody>
        </p:sp>
        <p:cxnSp>
          <p:nvCxnSpPr>
            <p:cNvPr id="69" name="Straight Arrow Connector 68">
              <a:extLst>
                <a:ext uri="{FF2B5EF4-FFF2-40B4-BE49-F238E27FC236}">
                  <a16:creationId xmlns:a16="http://schemas.microsoft.com/office/drawing/2014/main" id="{542D8700-83B8-4520-B05E-4A0F71D19AD2}"/>
                </a:ext>
              </a:extLst>
            </p:cNvPr>
            <p:cNvCxnSpPr>
              <a:cxnSpLocks/>
              <a:stCxn id="56" idx="2"/>
              <a:endCxn id="79" idx="0"/>
            </p:cNvCxnSpPr>
            <p:nvPr/>
          </p:nvCxnSpPr>
          <p:spPr>
            <a:xfrm flipH="1">
              <a:off x="2897492" y="2218253"/>
              <a:ext cx="9270" cy="551702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DF69343A-E8CB-46F5-B0EC-B983A60DD2D9}"/>
                </a:ext>
              </a:extLst>
            </p:cNvPr>
            <p:cNvCxnSpPr>
              <a:cxnSpLocks/>
              <a:stCxn id="57" idx="2"/>
              <a:endCxn id="83" idx="0"/>
            </p:cNvCxnSpPr>
            <p:nvPr/>
          </p:nvCxnSpPr>
          <p:spPr>
            <a:xfrm flipH="1">
              <a:off x="7091321" y="2392778"/>
              <a:ext cx="4692" cy="39307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3D8423DD-7AB8-45A2-9BDD-3D262263A3DA}"/>
                </a:ext>
              </a:extLst>
            </p:cNvPr>
            <p:cNvCxnSpPr>
              <a:cxnSpLocks/>
              <a:stCxn id="57" idx="2"/>
              <a:endCxn id="79" idx="0"/>
            </p:cNvCxnSpPr>
            <p:nvPr/>
          </p:nvCxnSpPr>
          <p:spPr>
            <a:xfrm flipH="1">
              <a:off x="2897492" y="2392778"/>
              <a:ext cx="4198521" cy="37717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953CCEE9-7186-4A37-9C19-39A97CE168F9}"/>
                </a:ext>
              </a:extLst>
            </p:cNvPr>
            <p:cNvSpPr txBox="1"/>
            <p:nvPr/>
          </p:nvSpPr>
          <p:spPr>
            <a:xfrm>
              <a:off x="1881001" y="3207779"/>
              <a:ext cx="2029569" cy="26161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err="1"/>
                <a:t>mWRD</a:t>
              </a:r>
              <a:r>
                <a:rPr lang="en-GB" sz="1100" dirty="0"/>
                <a:t> test (</a:t>
              </a:r>
              <a:r>
                <a:rPr lang="en-GB" sz="1100" dirty="0" err="1"/>
                <a:t>Xpert</a:t>
              </a:r>
              <a:r>
                <a:rPr lang="en-GB" sz="1100"/>
                <a:t> MTB-Rif</a:t>
              </a:r>
              <a:r>
                <a:rPr lang="en-GB" sz="1100" dirty="0"/>
                <a:t>)</a:t>
              </a:r>
              <a:endParaRPr lang="en-GB" sz="1100" dirty="0">
                <a:solidFill>
                  <a:srgbClr val="FF0000"/>
                </a:solidFill>
              </a:endParaRPr>
            </a:p>
          </p:txBody>
        </p:sp>
        <p:cxnSp>
          <p:nvCxnSpPr>
            <p:cNvPr id="104" name="Straight Arrow Connector 103">
              <a:extLst>
                <a:ext uri="{FF2B5EF4-FFF2-40B4-BE49-F238E27FC236}">
                  <a16:creationId xmlns:a16="http://schemas.microsoft.com/office/drawing/2014/main" id="{68B8FCC4-04AA-4826-9A52-214C2CDA84E1}"/>
                </a:ext>
              </a:extLst>
            </p:cNvPr>
            <p:cNvCxnSpPr>
              <a:cxnSpLocks/>
              <a:stCxn id="106" idx="3"/>
              <a:endCxn id="77" idx="1"/>
            </p:cNvCxnSpPr>
            <p:nvPr/>
          </p:nvCxnSpPr>
          <p:spPr>
            <a:xfrm flipV="1">
              <a:off x="5610311" y="3472150"/>
              <a:ext cx="383017" cy="5615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Elbow Connector 5">
              <a:extLst>
                <a:ext uri="{FF2B5EF4-FFF2-40B4-BE49-F238E27FC236}">
                  <a16:creationId xmlns:a16="http://schemas.microsoft.com/office/drawing/2014/main" id="{833E90AC-9F5C-AF4E-A1F8-DDAF346A2C46}"/>
                </a:ext>
              </a:extLst>
            </p:cNvPr>
            <p:cNvCxnSpPr>
              <a:cxnSpLocks/>
              <a:stCxn id="36" idx="2"/>
              <a:endCxn id="57" idx="0"/>
            </p:cNvCxnSpPr>
            <p:nvPr/>
          </p:nvCxnSpPr>
          <p:spPr>
            <a:xfrm rot="16200000" flipH="1">
              <a:off x="5820993" y="179039"/>
              <a:ext cx="475544" cy="2074496"/>
            </a:xfrm>
            <a:prstGeom prst="bentConnector3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Elbow Connector 7">
              <a:extLst>
                <a:ext uri="{FF2B5EF4-FFF2-40B4-BE49-F238E27FC236}">
                  <a16:creationId xmlns:a16="http://schemas.microsoft.com/office/drawing/2014/main" id="{2299A5CA-EDE8-3446-BCF3-9C9039C51F0E}"/>
                </a:ext>
              </a:extLst>
            </p:cNvPr>
            <p:cNvCxnSpPr>
              <a:stCxn id="36" idx="2"/>
              <a:endCxn id="56" idx="0"/>
            </p:cNvCxnSpPr>
            <p:nvPr/>
          </p:nvCxnSpPr>
          <p:spPr>
            <a:xfrm rot="5400000">
              <a:off x="3728992" y="156286"/>
              <a:ext cx="470297" cy="2114755"/>
            </a:xfrm>
            <a:prstGeom prst="bentConnector3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Elbow Connector 11">
              <a:extLst>
                <a:ext uri="{FF2B5EF4-FFF2-40B4-BE49-F238E27FC236}">
                  <a16:creationId xmlns:a16="http://schemas.microsoft.com/office/drawing/2014/main" id="{5A0D8C84-E651-1244-BA26-5CA8ABAFB96D}"/>
                </a:ext>
              </a:extLst>
            </p:cNvPr>
            <p:cNvCxnSpPr>
              <a:cxnSpLocks/>
              <a:stCxn id="38" idx="3"/>
              <a:endCxn id="106" idx="2"/>
            </p:cNvCxnSpPr>
            <p:nvPr/>
          </p:nvCxnSpPr>
          <p:spPr>
            <a:xfrm flipV="1">
              <a:off x="4936862" y="3693208"/>
              <a:ext cx="191270" cy="1423542"/>
            </a:xfrm>
            <a:prstGeom prst="bentConnector2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2F407E51-9989-2246-A0ED-4937F8E3F6E3}"/>
                </a:ext>
              </a:extLst>
            </p:cNvPr>
            <p:cNvCxnSpPr>
              <a:stCxn id="35" idx="2"/>
              <a:endCxn id="36" idx="0"/>
            </p:cNvCxnSpPr>
            <p:nvPr/>
          </p:nvCxnSpPr>
          <p:spPr>
            <a:xfrm>
              <a:off x="5009056" y="446026"/>
              <a:ext cx="12461" cy="27087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158374CE-E08F-7F4F-B650-FE2242AADBFB}"/>
                </a:ext>
              </a:extLst>
            </p:cNvPr>
            <p:cNvCxnSpPr>
              <a:stCxn id="77" idx="2"/>
              <a:endCxn id="107" idx="0"/>
            </p:cNvCxnSpPr>
            <p:nvPr/>
          </p:nvCxnSpPr>
          <p:spPr>
            <a:xfrm flipH="1">
              <a:off x="7080032" y="3602955"/>
              <a:ext cx="951" cy="2023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9DB1DBE1-F7B3-BD4C-BD1B-A0B9EC3A5D33}"/>
                </a:ext>
              </a:extLst>
            </p:cNvPr>
            <p:cNvCxnSpPr>
              <a:cxnSpLocks/>
              <a:stCxn id="38" idx="1"/>
              <a:endCxn id="82" idx="3"/>
            </p:cNvCxnSpPr>
            <p:nvPr/>
          </p:nvCxnSpPr>
          <p:spPr>
            <a:xfrm flipH="1">
              <a:off x="2961602" y="5116750"/>
              <a:ext cx="317321" cy="1133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CA3FC868-AE17-5F46-8D15-0B1A3935A027}"/>
                </a:ext>
              </a:extLst>
            </p:cNvPr>
            <p:cNvCxnSpPr>
              <a:cxnSpLocks/>
              <a:stCxn id="77" idx="3"/>
              <a:endCxn id="151" idx="1"/>
            </p:cNvCxnSpPr>
            <p:nvPr/>
          </p:nvCxnSpPr>
          <p:spPr>
            <a:xfrm flipV="1">
              <a:off x="8168638" y="3468378"/>
              <a:ext cx="343546" cy="377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FE93F7B-BDAE-3642-8490-DA147A3B9F1F}"/>
              </a:ext>
            </a:extLst>
          </p:cNvPr>
          <p:cNvSpPr txBox="1"/>
          <p:nvPr/>
        </p:nvSpPr>
        <p:spPr>
          <a:xfrm>
            <a:off x="8645236" y="184416"/>
            <a:ext cx="2814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800" b="1" dirty="0">
                <a:solidFill>
                  <a:srgbClr val="FF0000"/>
                </a:solidFill>
              </a:rPr>
              <a:t>Algorithm for systematic screening of PLHIV</a:t>
            </a:r>
          </a:p>
        </p:txBody>
      </p:sp>
    </p:spTree>
    <p:extLst>
      <p:ext uri="{BB962C8B-B14F-4D97-AF65-F5344CB8AC3E}">
        <p14:creationId xmlns:p14="http://schemas.microsoft.com/office/powerpoint/2010/main" val="3791485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D8526BEA-1D02-AB42-90F3-7FB8F64A8A3E}"/>
              </a:ext>
            </a:extLst>
          </p:cNvPr>
          <p:cNvSpPr/>
          <p:nvPr/>
        </p:nvSpPr>
        <p:spPr>
          <a:xfrm>
            <a:off x="4904510" y="51950"/>
            <a:ext cx="1983171" cy="72523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Symptom screening + Chest X-Ray+ CAD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B329E05-B689-4645-95E2-C668172C4746}"/>
              </a:ext>
            </a:extLst>
          </p:cNvPr>
          <p:cNvSpPr/>
          <p:nvPr/>
        </p:nvSpPr>
        <p:spPr>
          <a:xfrm>
            <a:off x="3759067" y="2009842"/>
            <a:ext cx="2853465" cy="58717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>
                <a:solidFill>
                  <a:schemeClr val="tx1"/>
                </a:solidFill>
              </a:rPr>
              <a:t>mWRDs</a:t>
            </a:r>
            <a:r>
              <a:rPr lang="en-GB" sz="1600" dirty="0">
                <a:solidFill>
                  <a:schemeClr val="tx1"/>
                </a:solidFill>
              </a:rPr>
              <a:t> (</a:t>
            </a:r>
            <a:r>
              <a:rPr lang="en-GB" sz="1600" dirty="0" err="1">
                <a:solidFill>
                  <a:schemeClr val="tx1"/>
                </a:solidFill>
              </a:rPr>
              <a:t>Xpert</a:t>
            </a:r>
            <a:r>
              <a:rPr lang="en-GB" sz="1600" dirty="0">
                <a:solidFill>
                  <a:schemeClr val="tx1"/>
                </a:solidFill>
              </a:rPr>
              <a:t> MTB/Rif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734D89A-9AC1-D54C-958D-8834BF5E700E}"/>
              </a:ext>
            </a:extLst>
          </p:cNvPr>
          <p:cNvSpPr/>
          <p:nvPr/>
        </p:nvSpPr>
        <p:spPr>
          <a:xfrm>
            <a:off x="2328436" y="3140009"/>
            <a:ext cx="1463040" cy="38301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>
                <a:solidFill>
                  <a:schemeClr val="tx1"/>
                </a:solidFill>
              </a:rPr>
              <a:t>M.tb</a:t>
            </a:r>
            <a:r>
              <a:rPr lang="en-GB" sz="1600" dirty="0">
                <a:solidFill>
                  <a:schemeClr val="tx1"/>
                </a:solidFill>
              </a:rPr>
              <a:t> Positive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457BA7E-78A6-FB44-AD34-0931ADD6D2F2}"/>
              </a:ext>
            </a:extLst>
          </p:cNvPr>
          <p:cNvSpPr/>
          <p:nvPr/>
        </p:nvSpPr>
        <p:spPr>
          <a:xfrm>
            <a:off x="5485296" y="3140009"/>
            <a:ext cx="1463040" cy="38301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>
                <a:solidFill>
                  <a:schemeClr val="tx1"/>
                </a:solidFill>
              </a:rPr>
              <a:t>M.tb</a:t>
            </a:r>
            <a:r>
              <a:rPr lang="en-GB" sz="1600" dirty="0">
                <a:solidFill>
                  <a:schemeClr val="tx1"/>
                </a:solidFill>
              </a:rPr>
              <a:t> negative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27BADF6-C71C-924D-98A3-6572EDBD9E31}"/>
              </a:ext>
            </a:extLst>
          </p:cNvPr>
          <p:cNvSpPr/>
          <p:nvPr/>
        </p:nvSpPr>
        <p:spPr>
          <a:xfrm>
            <a:off x="5210976" y="3976967"/>
            <a:ext cx="2036064" cy="6337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Clinical evaluation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8D4B64B-15F8-8C4F-9378-9198A0D60C88}"/>
              </a:ext>
            </a:extLst>
          </p:cNvPr>
          <p:cNvSpPr/>
          <p:nvPr/>
        </p:nvSpPr>
        <p:spPr>
          <a:xfrm>
            <a:off x="5521872" y="5005080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TB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985A960-0FB2-9545-AF9C-8A4C73A6C7BE}"/>
              </a:ext>
            </a:extLst>
          </p:cNvPr>
          <p:cNvSpPr/>
          <p:nvPr/>
        </p:nvSpPr>
        <p:spPr>
          <a:xfrm>
            <a:off x="8247655" y="3057855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No TB</a:t>
            </a:r>
          </a:p>
        </p:txBody>
      </p:sp>
      <p:cxnSp>
        <p:nvCxnSpPr>
          <p:cNvPr id="25" name="Elbow Connector 24">
            <a:extLst>
              <a:ext uri="{FF2B5EF4-FFF2-40B4-BE49-F238E27FC236}">
                <a16:creationId xmlns:a16="http://schemas.microsoft.com/office/drawing/2014/main" id="{02722083-90CE-7249-9905-F073830DB5CA}"/>
              </a:ext>
            </a:extLst>
          </p:cNvPr>
          <p:cNvCxnSpPr>
            <a:cxnSpLocks/>
            <a:stCxn id="5" idx="2"/>
            <a:endCxn id="6" idx="0"/>
          </p:cNvCxnSpPr>
          <p:nvPr/>
        </p:nvCxnSpPr>
        <p:spPr>
          <a:xfrm rot="5400000">
            <a:off x="3851384" y="1805592"/>
            <a:ext cx="542989" cy="2125844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Elbow Connector 26">
            <a:extLst>
              <a:ext uri="{FF2B5EF4-FFF2-40B4-BE49-F238E27FC236}">
                <a16:creationId xmlns:a16="http://schemas.microsoft.com/office/drawing/2014/main" id="{4229C19C-78F8-1647-ACB0-8469C829784E}"/>
              </a:ext>
            </a:extLst>
          </p:cNvPr>
          <p:cNvCxnSpPr>
            <a:cxnSpLocks/>
            <a:stCxn id="5" idx="2"/>
            <a:endCxn id="7" idx="0"/>
          </p:cNvCxnSpPr>
          <p:nvPr/>
        </p:nvCxnSpPr>
        <p:spPr>
          <a:xfrm rot="16200000" flipH="1">
            <a:off x="5429814" y="2353006"/>
            <a:ext cx="542989" cy="1031016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80B1F4D4-30A8-364B-816A-055CE53716EA}"/>
              </a:ext>
            </a:extLst>
          </p:cNvPr>
          <p:cNvCxnSpPr>
            <a:cxnSpLocks/>
            <a:stCxn id="10" idx="3"/>
            <a:endCxn id="13" idx="1"/>
          </p:cNvCxnSpPr>
          <p:nvPr/>
        </p:nvCxnSpPr>
        <p:spPr>
          <a:xfrm flipV="1">
            <a:off x="7247040" y="3249365"/>
            <a:ext cx="1000615" cy="10444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AB0318DB-6E8C-8942-935A-C6E1E3057634}"/>
              </a:ext>
            </a:extLst>
          </p:cNvPr>
          <p:cNvCxnSpPr>
            <a:cxnSpLocks/>
            <a:stCxn id="7" idx="2"/>
            <a:endCxn id="10" idx="0"/>
          </p:cNvCxnSpPr>
          <p:nvPr/>
        </p:nvCxnSpPr>
        <p:spPr>
          <a:xfrm>
            <a:off x="6216816" y="3523028"/>
            <a:ext cx="12192" cy="4539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3FC662C9-0FAA-6C4A-8DB7-DDB2733B0F80}"/>
              </a:ext>
            </a:extLst>
          </p:cNvPr>
          <p:cNvCxnSpPr>
            <a:cxnSpLocks/>
            <a:stCxn id="10" idx="2"/>
            <a:endCxn id="11" idx="0"/>
          </p:cNvCxnSpPr>
          <p:nvPr/>
        </p:nvCxnSpPr>
        <p:spPr>
          <a:xfrm>
            <a:off x="6229008" y="4610714"/>
            <a:ext cx="12192" cy="39436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0FB80986-5926-404F-B4FE-DF249461D651}"/>
              </a:ext>
            </a:extLst>
          </p:cNvPr>
          <p:cNvCxnSpPr>
            <a:cxnSpLocks/>
            <a:stCxn id="3" idx="2"/>
          </p:cNvCxnSpPr>
          <p:nvPr/>
        </p:nvCxnSpPr>
        <p:spPr>
          <a:xfrm flipH="1">
            <a:off x="5725886" y="777183"/>
            <a:ext cx="17021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BD836749-49AE-7E40-9BF4-7DEA0D5BBD57}"/>
              </a:ext>
            </a:extLst>
          </p:cNvPr>
          <p:cNvCxnSpPr>
            <a:cxnSpLocks/>
            <a:stCxn id="3" idx="2"/>
          </p:cNvCxnSpPr>
          <p:nvPr/>
        </p:nvCxnSpPr>
        <p:spPr>
          <a:xfrm flipH="1">
            <a:off x="5604095" y="777183"/>
            <a:ext cx="292001" cy="4539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74">
            <a:extLst>
              <a:ext uri="{FF2B5EF4-FFF2-40B4-BE49-F238E27FC236}">
                <a16:creationId xmlns:a16="http://schemas.microsoft.com/office/drawing/2014/main" id="{3BC86454-6AC1-324B-BF3D-F9584761EAA5}"/>
              </a:ext>
            </a:extLst>
          </p:cNvPr>
          <p:cNvSpPr/>
          <p:nvPr/>
        </p:nvSpPr>
        <p:spPr>
          <a:xfrm>
            <a:off x="287613" y="68268"/>
            <a:ext cx="3751974" cy="72522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FF0000"/>
                </a:solidFill>
              </a:rPr>
              <a:t>Algorithm for ACF: household contacts+ high risk clinical groups (who are eligible for TPT)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9E6D8CBD-A92B-6548-8C6A-34DAC7D16587}"/>
              </a:ext>
            </a:extLst>
          </p:cNvPr>
          <p:cNvSpPr/>
          <p:nvPr/>
        </p:nvSpPr>
        <p:spPr>
          <a:xfrm>
            <a:off x="7365344" y="210657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Negative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AF7E5867-E073-D642-8D0C-E35F66062B81}"/>
              </a:ext>
            </a:extLst>
          </p:cNvPr>
          <p:cNvCxnSpPr>
            <a:cxnSpLocks/>
            <a:stCxn id="3" idx="3"/>
            <a:endCxn id="48" idx="1"/>
          </p:cNvCxnSpPr>
          <p:nvPr/>
        </p:nvCxnSpPr>
        <p:spPr>
          <a:xfrm flipV="1">
            <a:off x="6887681" y="402167"/>
            <a:ext cx="477663" cy="124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Elbow Connector 28">
            <a:extLst>
              <a:ext uri="{FF2B5EF4-FFF2-40B4-BE49-F238E27FC236}">
                <a16:creationId xmlns:a16="http://schemas.microsoft.com/office/drawing/2014/main" id="{8291934F-65E0-2B41-9462-373131EFBA71}"/>
              </a:ext>
            </a:extLst>
          </p:cNvPr>
          <p:cNvCxnSpPr>
            <a:stCxn id="48" idx="3"/>
            <a:endCxn id="13" idx="0"/>
          </p:cNvCxnSpPr>
          <p:nvPr/>
        </p:nvCxnSpPr>
        <p:spPr>
          <a:xfrm>
            <a:off x="8804000" y="402167"/>
            <a:ext cx="162983" cy="2655688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5D2E0DFF-E60C-0D45-9E2D-B707F25321E8}"/>
              </a:ext>
            </a:extLst>
          </p:cNvPr>
          <p:cNvSpPr/>
          <p:nvPr/>
        </p:nvSpPr>
        <p:spPr>
          <a:xfrm>
            <a:off x="8271405" y="4888087"/>
            <a:ext cx="1346783" cy="56082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TPT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8687ED55-4C65-8547-8B45-233CD3CB77D4}"/>
              </a:ext>
            </a:extLst>
          </p:cNvPr>
          <p:cNvCxnSpPr>
            <a:cxnSpLocks/>
            <a:stCxn id="75" idx="3"/>
            <a:endCxn id="3" idx="1"/>
          </p:cNvCxnSpPr>
          <p:nvPr/>
        </p:nvCxnSpPr>
        <p:spPr>
          <a:xfrm flipV="1">
            <a:off x="4039587" y="414567"/>
            <a:ext cx="864923" cy="163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angle 71">
            <a:extLst>
              <a:ext uri="{FF2B5EF4-FFF2-40B4-BE49-F238E27FC236}">
                <a16:creationId xmlns:a16="http://schemas.microsoft.com/office/drawing/2014/main" id="{4038EC07-5B5E-F647-AE33-77E884456F12}"/>
              </a:ext>
            </a:extLst>
          </p:cNvPr>
          <p:cNvSpPr/>
          <p:nvPr/>
        </p:nvSpPr>
        <p:spPr>
          <a:xfrm>
            <a:off x="8236604" y="3726172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Age &lt; 5 years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CB7A5AC-362E-0D47-B121-A5A874580AA7}"/>
              </a:ext>
            </a:extLst>
          </p:cNvPr>
          <p:cNvSpPr/>
          <p:nvPr/>
        </p:nvSpPr>
        <p:spPr>
          <a:xfrm>
            <a:off x="8236604" y="4307129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Yes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AB779FDA-DBE1-E744-9273-6646CDCC6B8A}"/>
              </a:ext>
            </a:extLst>
          </p:cNvPr>
          <p:cNvSpPr/>
          <p:nvPr/>
        </p:nvSpPr>
        <p:spPr>
          <a:xfrm>
            <a:off x="9956547" y="3726172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No</a:t>
            </a: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9BC58DCE-100A-4C48-A720-7CB26F113F7C}"/>
              </a:ext>
            </a:extLst>
          </p:cNvPr>
          <p:cNvSpPr/>
          <p:nvPr/>
        </p:nvSpPr>
        <p:spPr>
          <a:xfrm>
            <a:off x="9956547" y="4327265"/>
            <a:ext cx="1438656" cy="56082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TB Infection test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F613A2BA-F59B-6247-8E67-A3F9C670427E}"/>
              </a:ext>
            </a:extLst>
          </p:cNvPr>
          <p:cNvSpPr/>
          <p:nvPr/>
        </p:nvSpPr>
        <p:spPr>
          <a:xfrm>
            <a:off x="9956547" y="5106159"/>
            <a:ext cx="1438656" cy="56082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Positive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6A9A8CC7-F85B-1F4A-8710-851BF67EAC00}"/>
              </a:ext>
            </a:extLst>
          </p:cNvPr>
          <p:cNvSpPr/>
          <p:nvPr/>
        </p:nvSpPr>
        <p:spPr>
          <a:xfrm>
            <a:off x="9956547" y="5885053"/>
            <a:ext cx="1438656" cy="37604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TPT</a:t>
            </a:r>
          </a:p>
        </p:txBody>
      </p: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F5126B8F-22E5-5849-A6DC-CB1D0E6D883E}"/>
              </a:ext>
            </a:extLst>
          </p:cNvPr>
          <p:cNvCxnSpPr>
            <a:stCxn id="13" idx="2"/>
            <a:endCxn id="72" idx="0"/>
          </p:cNvCxnSpPr>
          <p:nvPr/>
        </p:nvCxnSpPr>
        <p:spPr>
          <a:xfrm flipH="1">
            <a:off x="8955932" y="3440875"/>
            <a:ext cx="11051" cy="2852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C898A333-7D62-4446-B63F-C1A8E4B676F4}"/>
              </a:ext>
            </a:extLst>
          </p:cNvPr>
          <p:cNvCxnSpPr>
            <a:stCxn id="72" idx="2"/>
            <a:endCxn id="73" idx="0"/>
          </p:cNvCxnSpPr>
          <p:nvPr/>
        </p:nvCxnSpPr>
        <p:spPr>
          <a:xfrm>
            <a:off x="8955932" y="4109192"/>
            <a:ext cx="0" cy="1979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698459A4-B64F-D34C-A2A0-7F7735910C46}"/>
              </a:ext>
            </a:extLst>
          </p:cNvPr>
          <p:cNvCxnSpPr>
            <a:cxnSpLocks/>
            <a:stCxn id="73" idx="2"/>
            <a:endCxn id="56" idx="0"/>
          </p:cNvCxnSpPr>
          <p:nvPr/>
        </p:nvCxnSpPr>
        <p:spPr>
          <a:xfrm flipH="1">
            <a:off x="8944797" y="4690149"/>
            <a:ext cx="11135" cy="1979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7C728F4B-8E5F-CA48-AB58-7468808AC5C5}"/>
              </a:ext>
            </a:extLst>
          </p:cNvPr>
          <p:cNvCxnSpPr>
            <a:stCxn id="72" idx="3"/>
            <a:endCxn id="74" idx="1"/>
          </p:cNvCxnSpPr>
          <p:nvPr/>
        </p:nvCxnSpPr>
        <p:spPr>
          <a:xfrm>
            <a:off x="9675260" y="3917682"/>
            <a:ext cx="28128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70F7B79C-F888-3B4A-A2E9-9A72E719334F}"/>
              </a:ext>
            </a:extLst>
          </p:cNvPr>
          <p:cNvCxnSpPr>
            <a:stCxn id="74" idx="2"/>
            <a:endCxn id="76" idx="0"/>
          </p:cNvCxnSpPr>
          <p:nvPr/>
        </p:nvCxnSpPr>
        <p:spPr>
          <a:xfrm>
            <a:off x="10675875" y="4109192"/>
            <a:ext cx="0" cy="21807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3DF855AB-34A6-B144-AA37-245F7D7BD999}"/>
              </a:ext>
            </a:extLst>
          </p:cNvPr>
          <p:cNvCxnSpPr>
            <a:stCxn id="76" idx="2"/>
            <a:endCxn id="77" idx="0"/>
          </p:cNvCxnSpPr>
          <p:nvPr/>
        </p:nvCxnSpPr>
        <p:spPr>
          <a:xfrm>
            <a:off x="10675875" y="4888086"/>
            <a:ext cx="0" cy="21807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CDD4630F-9212-C84E-BFB7-228B4DF3F1C1}"/>
              </a:ext>
            </a:extLst>
          </p:cNvPr>
          <p:cNvCxnSpPr>
            <a:cxnSpLocks/>
            <a:stCxn id="77" idx="2"/>
            <a:endCxn id="78" idx="0"/>
          </p:cNvCxnSpPr>
          <p:nvPr/>
        </p:nvCxnSpPr>
        <p:spPr>
          <a:xfrm>
            <a:off x="10675875" y="5666980"/>
            <a:ext cx="0" cy="21807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>
            <a:extLst>
              <a:ext uri="{FF2B5EF4-FFF2-40B4-BE49-F238E27FC236}">
                <a16:creationId xmlns:a16="http://schemas.microsoft.com/office/drawing/2014/main" id="{01C6B372-A54F-23F0-4D23-58486687288D}"/>
              </a:ext>
            </a:extLst>
          </p:cNvPr>
          <p:cNvSpPr/>
          <p:nvPr/>
        </p:nvSpPr>
        <p:spPr>
          <a:xfrm>
            <a:off x="2335703" y="4038484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TB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7A26B8D3-6E33-DC6A-799B-F1FF73579460}"/>
              </a:ext>
            </a:extLst>
          </p:cNvPr>
          <p:cNvCxnSpPr>
            <a:cxnSpLocks/>
            <a:endCxn id="8" idx="0"/>
          </p:cNvCxnSpPr>
          <p:nvPr/>
        </p:nvCxnSpPr>
        <p:spPr>
          <a:xfrm flipH="1">
            <a:off x="3055031" y="3523028"/>
            <a:ext cx="17625" cy="5154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:a16="http://schemas.microsoft.com/office/drawing/2014/main" id="{96D5D154-1E6F-4700-ADD2-0FFF36D24B76}"/>
              </a:ext>
            </a:extLst>
          </p:cNvPr>
          <p:cNvSpPr/>
          <p:nvPr/>
        </p:nvSpPr>
        <p:spPr>
          <a:xfrm>
            <a:off x="4788469" y="1239047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Positive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C8B9BA15-AF64-4820-BE02-D946934A123C}"/>
              </a:ext>
            </a:extLst>
          </p:cNvPr>
          <p:cNvCxnSpPr>
            <a:cxnSpLocks/>
            <a:stCxn id="42" idx="2"/>
          </p:cNvCxnSpPr>
          <p:nvPr/>
        </p:nvCxnSpPr>
        <p:spPr>
          <a:xfrm flipH="1">
            <a:off x="5185803" y="1622067"/>
            <a:ext cx="321994" cy="4208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729952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D8526BEA-1D02-AB42-90F3-7FB8F64A8A3E}"/>
              </a:ext>
            </a:extLst>
          </p:cNvPr>
          <p:cNvSpPr/>
          <p:nvPr/>
        </p:nvSpPr>
        <p:spPr>
          <a:xfrm>
            <a:off x="4777506" y="422491"/>
            <a:ext cx="2006925" cy="84398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Symptom screening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B329E05-B689-4645-95E2-C668172C4746}"/>
              </a:ext>
            </a:extLst>
          </p:cNvPr>
          <p:cNvSpPr/>
          <p:nvPr/>
        </p:nvSpPr>
        <p:spPr>
          <a:xfrm>
            <a:off x="4377032" y="3074358"/>
            <a:ext cx="2853465" cy="53379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>
                <a:solidFill>
                  <a:schemeClr val="tx1"/>
                </a:solidFill>
              </a:rPr>
              <a:t>mWRDs</a:t>
            </a:r>
            <a:r>
              <a:rPr lang="en-GB" sz="1600" dirty="0">
                <a:solidFill>
                  <a:schemeClr val="tx1"/>
                </a:solidFill>
              </a:rPr>
              <a:t> (</a:t>
            </a:r>
            <a:r>
              <a:rPr lang="en-GB" sz="1600" dirty="0" err="1">
                <a:solidFill>
                  <a:schemeClr val="tx1"/>
                </a:solidFill>
              </a:rPr>
              <a:t>Xpert</a:t>
            </a:r>
            <a:r>
              <a:rPr lang="en-GB" sz="1600" dirty="0">
                <a:solidFill>
                  <a:schemeClr val="tx1"/>
                </a:solidFill>
              </a:rPr>
              <a:t> MTB/Rif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734D89A-9AC1-D54C-958D-8834BF5E700E}"/>
              </a:ext>
            </a:extLst>
          </p:cNvPr>
          <p:cNvSpPr/>
          <p:nvPr/>
        </p:nvSpPr>
        <p:spPr>
          <a:xfrm>
            <a:off x="2946401" y="4195244"/>
            <a:ext cx="1463040" cy="34820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>
                <a:solidFill>
                  <a:schemeClr val="tx1"/>
                </a:solidFill>
              </a:rPr>
              <a:t>M.tb</a:t>
            </a:r>
            <a:r>
              <a:rPr lang="en-GB" sz="1600" dirty="0">
                <a:solidFill>
                  <a:schemeClr val="tx1"/>
                </a:solidFill>
              </a:rPr>
              <a:t> Positive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457BA7E-78A6-FB44-AD34-0931ADD6D2F2}"/>
              </a:ext>
            </a:extLst>
          </p:cNvPr>
          <p:cNvSpPr/>
          <p:nvPr/>
        </p:nvSpPr>
        <p:spPr>
          <a:xfrm>
            <a:off x="6103261" y="4195244"/>
            <a:ext cx="1463040" cy="34820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 err="1">
                <a:solidFill>
                  <a:schemeClr val="tx1"/>
                </a:solidFill>
              </a:rPr>
              <a:t>M.tb</a:t>
            </a:r>
            <a:r>
              <a:rPr lang="en-GB" sz="1600" dirty="0">
                <a:solidFill>
                  <a:schemeClr val="tx1"/>
                </a:solidFill>
              </a:rPr>
              <a:t> Negative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985A960-0FB2-9545-AF9C-8A4C73A6C7BE}"/>
              </a:ext>
            </a:extLst>
          </p:cNvPr>
          <p:cNvSpPr/>
          <p:nvPr/>
        </p:nvSpPr>
        <p:spPr>
          <a:xfrm>
            <a:off x="8866421" y="4177834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No TB</a:t>
            </a:r>
          </a:p>
        </p:txBody>
      </p:sp>
      <p:cxnSp>
        <p:nvCxnSpPr>
          <p:cNvPr id="25" name="Elbow Connector 24">
            <a:extLst>
              <a:ext uri="{FF2B5EF4-FFF2-40B4-BE49-F238E27FC236}">
                <a16:creationId xmlns:a16="http://schemas.microsoft.com/office/drawing/2014/main" id="{02722083-90CE-7249-9905-F073830DB5CA}"/>
              </a:ext>
            </a:extLst>
          </p:cNvPr>
          <p:cNvCxnSpPr>
            <a:cxnSpLocks/>
            <a:stCxn id="5" idx="2"/>
            <a:endCxn id="6" idx="0"/>
          </p:cNvCxnSpPr>
          <p:nvPr/>
        </p:nvCxnSpPr>
        <p:spPr>
          <a:xfrm rot="5400000">
            <a:off x="4447299" y="2838778"/>
            <a:ext cx="587088" cy="2125844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Elbow Connector 26">
            <a:extLst>
              <a:ext uri="{FF2B5EF4-FFF2-40B4-BE49-F238E27FC236}">
                <a16:creationId xmlns:a16="http://schemas.microsoft.com/office/drawing/2014/main" id="{4229C19C-78F8-1647-ACB0-8469C829784E}"/>
              </a:ext>
            </a:extLst>
          </p:cNvPr>
          <p:cNvCxnSpPr>
            <a:cxnSpLocks/>
            <a:stCxn id="5" idx="2"/>
            <a:endCxn id="7" idx="0"/>
          </p:cNvCxnSpPr>
          <p:nvPr/>
        </p:nvCxnSpPr>
        <p:spPr>
          <a:xfrm rot="16200000" flipH="1">
            <a:off x="6025729" y="3386192"/>
            <a:ext cx="587088" cy="1031016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80B1F4D4-30A8-364B-816A-055CE53716EA}"/>
              </a:ext>
            </a:extLst>
          </p:cNvPr>
          <p:cNvCxnSpPr>
            <a:cxnSpLocks/>
            <a:stCxn id="7" idx="3"/>
            <a:endCxn id="13" idx="1"/>
          </p:cNvCxnSpPr>
          <p:nvPr/>
        </p:nvCxnSpPr>
        <p:spPr>
          <a:xfrm flipV="1">
            <a:off x="7566301" y="4369344"/>
            <a:ext cx="130012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BD836749-49AE-7E40-9BF4-7DEA0D5BBD57}"/>
              </a:ext>
            </a:extLst>
          </p:cNvPr>
          <p:cNvCxnSpPr>
            <a:cxnSpLocks/>
            <a:stCxn id="19" idx="2"/>
            <a:endCxn id="5" idx="0"/>
          </p:cNvCxnSpPr>
          <p:nvPr/>
        </p:nvCxnSpPr>
        <p:spPr>
          <a:xfrm>
            <a:off x="5792366" y="2238243"/>
            <a:ext cx="11399" cy="8361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74">
            <a:extLst>
              <a:ext uri="{FF2B5EF4-FFF2-40B4-BE49-F238E27FC236}">
                <a16:creationId xmlns:a16="http://schemas.microsoft.com/office/drawing/2014/main" id="{3BC86454-6AC1-324B-BF3D-F9584761EAA5}"/>
              </a:ext>
            </a:extLst>
          </p:cNvPr>
          <p:cNvSpPr/>
          <p:nvPr/>
        </p:nvSpPr>
        <p:spPr>
          <a:xfrm>
            <a:off x="418570" y="292166"/>
            <a:ext cx="3661487" cy="112089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FF0000"/>
                </a:solidFill>
              </a:rPr>
              <a:t>Algorithm for ACF:</a:t>
            </a:r>
          </a:p>
          <a:p>
            <a:pPr algn="ctr"/>
            <a:r>
              <a:rPr lang="en-GB" sz="1600" b="1" dirty="0">
                <a:solidFill>
                  <a:srgbClr val="FF0000"/>
                </a:solidFill>
              </a:rPr>
              <a:t>Community based or high risk population groups (age &gt; 14 years)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9E6D8CBD-A92B-6548-8C6A-34DAC7D16587}"/>
              </a:ext>
            </a:extLst>
          </p:cNvPr>
          <p:cNvSpPr/>
          <p:nvPr/>
        </p:nvSpPr>
        <p:spPr>
          <a:xfrm>
            <a:off x="8648044" y="652453"/>
            <a:ext cx="18294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+ Chest X-Ray+ CAD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AF7E5867-E073-D642-8D0C-E35F66062B81}"/>
              </a:ext>
            </a:extLst>
          </p:cNvPr>
          <p:cNvCxnSpPr>
            <a:cxnSpLocks/>
            <a:stCxn id="24" idx="3"/>
            <a:endCxn id="48" idx="1"/>
          </p:cNvCxnSpPr>
          <p:nvPr/>
        </p:nvCxnSpPr>
        <p:spPr>
          <a:xfrm flipV="1">
            <a:off x="8049860" y="843963"/>
            <a:ext cx="598184" cy="114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8687ED55-4C65-8547-8B45-233CD3CB77D4}"/>
              </a:ext>
            </a:extLst>
          </p:cNvPr>
          <p:cNvCxnSpPr>
            <a:cxnSpLocks/>
            <a:stCxn id="75" idx="3"/>
            <a:endCxn id="3" idx="1"/>
          </p:cNvCxnSpPr>
          <p:nvPr/>
        </p:nvCxnSpPr>
        <p:spPr>
          <a:xfrm flipV="1">
            <a:off x="4080057" y="844483"/>
            <a:ext cx="697449" cy="81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C2B9A09F-3CD1-853A-48D9-2946637347A3}"/>
              </a:ext>
            </a:extLst>
          </p:cNvPr>
          <p:cNvSpPr/>
          <p:nvPr/>
        </p:nvSpPr>
        <p:spPr>
          <a:xfrm>
            <a:off x="4877638" y="1855223"/>
            <a:ext cx="18294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Positive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796BDD5F-FF13-FEA3-D2FB-240485EE693F}"/>
              </a:ext>
            </a:extLst>
          </p:cNvPr>
          <p:cNvCxnSpPr>
            <a:stCxn id="3" idx="2"/>
            <a:endCxn id="19" idx="0"/>
          </p:cNvCxnSpPr>
          <p:nvPr/>
        </p:nvCxnSpPr>
        <p:spPr>
          <a:xfrm>
            <a:off x="5780969" y="1266475"/>
            <a:ext cx="11397" cy="58874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>
            <a:extLst>
              <a:ext uri="{FF2B5EF4-FFF2-40B4-BE49-F238E27FC236}">
                <a16:creationId xmlns:a16="http://schemas.microsoft.com/office/drawing/2014/main" id="{2EB017B0-4B19-3ED8-5154-BC97F8754226}"/>
              </a:ext>
            </a:extLst>
          </p:cNvPr>
          <p:cNvSpPr/>
          <p:nvPr/>
        </p:nvSpPr>
        <p:spPr>
          <a:xfrm>
            <a:off x="6986175" y="663902"/>
            <a:ext cx="1063685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Negative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53789AE3-E886-2C36-9C18-CBD57289A4F5}"/>
              </a:ext>
            </a:extLst>
          </p:cNvPr>
          <p:cNvCxnSpPr>
            <a:stCxn id="3" idx="3"/>
            <a:endCxn id="24" idx="1"/>
          </p:cNvCxnSpPr>
          <p:nvPr/>
        </p:nvCxnSpPr>
        <p:spPr>
          <a:xfrm>
            <a:off x="6784431" y="844483"/>
            <a:ext cx="201744" cy="109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2835F839-2A49-6B26-9A56-A4564520B06C}"/>
              </a:ext>
            </a:extLst>
          </p:cNvPr>
          <p:cNvSpPr/>
          <p:nvPr/>
        </p:nvSpPr>
        <p:spPr>
          <a:xfrm>
            <a:off x="9056921" y="2607015"/>
            <a:ext cx="1063685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Negative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543344DE-5BC7-4867-3163-EA5EEFD892E2}"/>
              </a:ext>
            </a:extLst>
          </p:cNvPr>
          <p:cNvCxnSpPr>
            <a:stCxn id="48" idx="2"/>
            <a:endCxn id="33" idx="0"/>
          </p:cNvCxnSpPr>
          <p:nvPr/>
        </p:nvCxnSpPr>
        <p:spPr>
          <a:xfrm>
            <a:off x="9562772" y="1035473"/>
            <a:ext cx="25992" cy="157154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C95C3392-3B22-BA43-1D71-4654F2382399}"/>
              </a:ext>
            </a:extLst>
          </p:cNvPr>
          <p:cNvCxnSpPr>
            <a:stCxn id="33" idx="2"/>
            <a:endCxn id="13" idx="0"/>
          </p:cNvCxnSpPr>
          <p:nvPr/>
        </p:nvCxnSpPr>
        <p:spPr>
          <a:xfrm flipH="1">
            <a:off x="9585749" y="2990035"/>
            <a:ext cx="3015" cy="11877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Elbow Connector 39">
            <a:extLst>
              <a:ext uri="{FF2B5EF4-FFF2-40B4-BE49-F238E27FC236}">
                <a16:creationId xmlns:a16="http://schemas.microsoft.com/office/drawing/2014/main" id="{43E23C70-7B09-CDAB-8E35-D445E9ACEC2C}"/>
              </a:ext>
            </a:extLst>
          </p:cNvPr>
          <p:cNvCxnSpPr>
            <a:stCxn id="48" idx="2"/>
            <a:endCxn id="19" idx="3"/>
          </p:cNvCxnSpPr>
          <p:nvPr/>
        </p:nvCxnSpPr>
        <p:spPr>
          <a:xfrm rot="5400000">
            <a:off x="7629303" y="113264"/>
            <a:ext cx="1011260" cy="2855678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>
            <a:extLst>
              <a:ext uri="{FF2B5EF4-FFF2-40B4-BE49-F238E27FC236}">
                <a16:creationId xmlns:a16="http://schemas.microsoft.com/office/drawing/2014/main" id="{426EBA1E-4F16-D666-51F2-700C82F89294}"/>
              </a:ext>
            </a:extLst>
          </p:cNvPr>
          <p:cNvSpPr/>
          <p:nvPr/>
        </p:nvSpPr>
        <p:spPr>
          <a:xfrm>
            <a:off x="2958085" y="4782876"/>
            <a:ext cx="1438656" cy="3830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TB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0251C396-3AD9-68CB-303A-3ABB785720D8}"/>
              </a:ext>
            </a:extLst>
          </p:cNvPr>
          <p:cNvCxnSpPr>
            <a:stCxn id="6" idx="2"/>
            <a:endCxn id="41" idx="0"/>
          </p:cNvCxnSpPr>
          <p:nvPr/>
        </p:nvCxnSpPr>
        <p:spPr>
          <a:xfrm flipH="1">
            <a:off x="3677413" y="4543445"/>
            <a:ext cx="508" cy="2394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06076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1FD06B344BC9945A5C4F2D6B9D7DCEC" ma:contentTypeVersion="13" ma:contentTypeDescription="Create a new document." ma:contentTypeScope="" ma:versionID="fce906123bb245a19cf5ab6ff5a76650">
  <xsd:schema xmlns:xsd="http://www.w3.org/2001/XMLSchema" xmlns:xs="http://www.w3.org/2001/XMLSchema" xmlns:p="http://schemas.microsoft.com/office/2006/metadata/properties" xmlns:ns3="f3cc908b-7835-4406-8103-882adf824636" xmlns:ns4="29634fa1-07a7-4c33-981e-090b30ba7139" targetNamespace="http://schemas.microsoft.com/office/2006/metadata/properties" ma:root="true" ma:fieldsID="5ddb1c8e299960c45dc56ee64b4a9de2" ns3:_="" ns4:_="">
    <xsd:import namespace="f3cc908b-7835-4406-8103-882adf824636"/>
    <xsd:import namespace="29634fa1-07a7-4c33-981e-090b30ba713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3cc908b-7835-4406-8103-882adf82463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9634fa1-07a7-4c33-981e-090b30ba7139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8C730EF-2C40-43C0-8A77-F7F9CA72347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B1B5CD9-5BDA-4B69-A6A7-D928729AC916}">
  <ds:schemaRefs>
    <ds:schemaRef ds:uri="http://schemas.openxmlformats.org/package/2006/metadata/core-properties"/>
    <ds:schemaRef ds:uri="http://purl.org/dc/terms/"/>
    <ds:schemaRef ds:uri="http://schemas.microsoft.com/office/infopath/2007/PartnerControls"/>
    <ds:schemaRef ds:uri="http://schemas.microsoft.com/office/2006/documentManagement/types"/>
    <ds:schemaRef ds:uri="f3cc908b-7835-4406-8103-882adf824636"/>
    <ds:schemaRef ds:uri="http://schemas.microsoft.com/office/2006/metadata/properties"/>
    <ds:schemaRef ds:uri="http://purl.org/dc/elements/1.1/"/>
    <ds:schemaRef ds:uri="29634fa1-07a7-4c33-981e-090b30ba7139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E9052177-78F3-4143-A7F1-33D2DE54C8A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3cc908b-7835-4406-8103-882adf824636"/>
    <ds:schemaRef ds:uri="29634fa1-07a7-4c33-981e-090b30ba713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5126</TotalTime>
  <Words>248</Words>
  <Application>Microsoft Office PowerPoint</Application>
  <PresentationFormat>Widescreen</PresentationFormat>
  <Paragraphs>5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nath Satyanarayana</dc:creator>
  <cp:lastModifiedBy>DEN BOON, Saskia</cp:lastModifiedBy>
  <cp:revision>248</cp:revision>
  <dcterms:created xsi:type="dcterms:W3CDTF">2021-04-14T10:21:14Z</dcterms:created>
  <dcterms:modified xsi:type="dcterms:W3CDTF">2023-02-01T14:52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1FD06B344BC9945A5C4F2D6B9D7DCEC</vt:lpwstr>
  </property>
</Properties>
</file>